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11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F9E14E-7A32-EC0E-2166-CAA06BDC16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40D892F-5301-2445-CB6D-2E6CDC0284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EB9427-99F0-3F8F-8EA8-037B8F329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AA1B2F-C349-1F68-8D73-408E10FF6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CDE410-23ED-E06A-1DFD-933AA86BC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007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DB243D-B865-661C-950E-BF5EC92C9E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E93F8BC-78A6-50B7-4368-765772CAEA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C90E85-55A0-CDFE-2EDF-7170F3C16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600D43-B042-FB4F-317C-E39CDE48C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BC9B4C-7574-255F-6442-5EFBC920D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461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D6BAC82-5B28-9EF6-9ECE-C16301D790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2F15EE3-64EE-9C5C-2D6E-C4EA5E7EF6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D5DCC0-9CAC-2078-6A63-92B6ED4F1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45EE04-3A88-0853-9DF7-6A237B7CB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6174C1-4A0D-23A2-4E2C-92E225916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373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195CEC-7D02-D385-5B4B-642A389073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481D76F-605B-01A6-2E6D-29961CAEB9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5585EF-1484-2386-7983-9E38C68CC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B5411E-F705-0402-3243-1D4939FE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C058DE-1531-78A3-7AB6-73D369921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367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571B3F-AF50-FCA7-DA80-6FB95CD99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6D469E-1334-8F72-25A4-CB073FB927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65EFB1-8C1E-50E1-3523-FEDDF3EC7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510570-B857-6E3B-FD4F-B418738FA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E1E858-7650-2447-82A1-4ACA147E8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409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F5E390-4DC5-A466-4AD5-8FEED64BB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33ACE41-A646-9BC8-B6C8-248DE2714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3ADC59-6879-E746-B1CE-1D07FD2DCE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9E0B44C-A77D-9616-1629-06C3764D0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7B822D-540A-EC94-0DF1-1CD3547CE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4B4E0E-6EA4-0A63-8D9A-99DF7EED7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908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1FBEF8-8B32-A052-DF30-5B622AF38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4041F4D-2E59-48D4-0E84-20FCB1A4EB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4C149BC-944D-D1E5-5E78-CCFB7A26B2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DD488CA-79A4-39EA-8D09-2A586A0237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0173F9E-C55C-CFF7-017C-43402FC1E7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F5C87BF-CDA6-0F07-1277-27DC01C3D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B6A0672-3D17-284C-4178-63122B376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30729F8-4F19-9201-5441-265135BA4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225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9CFCF5-E6E1-6FBA-2F12-02E953175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220F99D-78A6-B4C7-3F96-8B420856E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D52BED8-462B-EAC1-E6B4-B9F0220FD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6252DB0-BD03-C7D4-00EE-22E145123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28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9AC5580-11CE-993E-ECA9-DFC61BC5A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A8272E5-979D-D814-D7DD-A129AB1F2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AC2BF08-C7CC-B587-6CA5-78DE86195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889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23323E-D3F6-B445-AFF6-5E4B5DB63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E17FA5B-0D81-E58D-01AD-518A496258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9D333CD-DF83-2EE8-648F-5BF419D328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89D19C-4F86-AD19-3EF2-06C2835E6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A68ECB4-6FEA-6F00-24F9-04CFF7634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92210FC-D7AA-25D0-3972-342AB3465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2213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AED291-8651-A3D5-D676-8CBC0EFFA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707C449-B99E-9746-7601-A3FF6A5B0A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42370FF-3C4E-BFB3-2F11-EE99AC5FEB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84B3C8-42F3-8C61-D934-E3A048C9F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2DDDD15-B7C8-1FD6-5F76-B071CFB94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918D02-8ADC-A664-77D9-1FC4A2E34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425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F522732-228D-40EB-227B-941C8F371E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F7D2913-F68B-53F1-EA3D-A94DA7F49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E5F1C5-1DCF-5ECA-5AE4-7DB9C5039F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BC03A-2E3C-4C69-AC87-D89479C3B3AC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A71E6C-C1C7-7D95-4256-9755782C2D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4C4E02B-73D1-6179-B978-AB775F57D9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24FDB-4A8D-4885-A961-4257FFC70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18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512BA8E3-CA33-4B96-6342-59FB5C35D984}"/>
              </a:ext>
            </a:extLst>
          </p:cNvPr>
          <p:cNvGrpSpPr/>
          <p:nvPr/>
        </p:nvGrpSpPr>
        <p:grpSpPr>
          <a:xfrm>
            <a:off x="2380939" y="90784"/>
            <a:ext cx="7646925" cy="6676431"/>
            <a:chOff x="2180770" y="142458"/>
            <a:chExt cx="7646925" cy="6676431"/>
          </a:xfrm>
        </p:grpSpPr>
        <p:pic>
          <p:nvPicPr>
            <p:cNvPr id="5" name="図 4" descr="屋内, 食品, テーブル, ミルク が含まれている画像&#10;&#10;自動的に生成された説明">
              <a:extLst>
                <a:ext uri="{FF2B5EF4-FFF2-40B4-BE49-F238E27FC236}">
                  <a16:creationId xmlns:a16="http://schemas.microsoft.com/office/drawing/2014/main" id="{8F752039-3A51-3679-9B0C-71BF6C9A623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1769953" y="553275"/>
              <a:ext cx="3286538" cy="2464904"/>
            </a:xfrm>
            <a:prstGeom prst="rect">
              <a:avLst/>
            </a:prstGeom>
          </p:spPr>
        </p:pic>
        <p:pic>
          <p:nvPicPr>
            <p:cNvPr id="7" name="図 6" descr="マップ&#10;&#10;自動的に生成された説明">
              <a:extLst>
                <a:ext uri="{FF2B5EF4-FFF2-40B4-BE49-F238E27FC236}">
                  <a16:creationId xmlns:a16="http://schemas.microsoft.com/office/drawing/2014/main" id="{5BAC8F28-B345-B9CC-970D-BCDDCEF0D2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368279" y="553282"/>
              <a:ext cx="3286540" cy="2464905"/>
            </a:xfrm>
            <a:prstGeom prst="rect">
              <a:avLst/>
            </a:prstGeom>
          </p:spPr>
        </p:pic>
        <p:pic>
          <p:nvPicPr>
            <p:cNvPr id="9" name="図 8" descr="雨 が含まれている画像&#10;&#10;自動的に生成された説明">
              <a:extLst>
                <a:ext uri="{FF2B5EF4-FFF2-40B4-BE49-F238E27FC236}">
                  <a16:creationId xmlns:a16="http://schemas.microsoft.com/office/drawing/2014/main" id="{1B92AB03-DAB6-F2E8-4044-44AD33D7AF4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401294" y="3943164"/>
              <a:ext cx="3286543" cy="2464907"/>
            </a:xfrm>
            <a:prstGeom prst="rect">
              <a:avLst/>
            </a:prstGeom>
          </p:spPr>
        </p:pic>
        <p:pic>
          <p:nvPicPr>
            <p:cNvPr id="11" name="図 10" descr="マップ&#10;&#10;中程度の精度で自動的に生成された説明">
              <a:extLst>
                <a:ext uri="{FF2B5EF4-FFF2-40B4-BE49-F238E27FC236}">
                  <a16:creationId xmlns:a16="http://schemas.microsoft.com/office/drawing/2014/main" id="{8B8C133B-7DC3-BC80-2E89-D4EED3D7319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6918956" y="553276"/>
              <a:ext cx="3286541" cy="2464906"/>
            </a:xfrm>
            <a:prstGeom prst="rect">
              <a:avLst/>
            </a:prstGeom>
          </p:spPr>
        </p:pic>
        <p:pic>
          <p:nvPicPr>
            <p:cNvPr id="13" name="図 12" descr="白い壁の前にいる&#10;&#10;中程度の精度で自動的に生成された説明">
              <a:extLst>
                <a:ext uri="{FF2B5EF4-FFF2-40B4-BE49-F238E27FC236}">
                  <a16:creationId xmlns:a16="http://schemas.microsoft.com/office/drawing/2014/main" id="{FF1AA9FB-2764-A2DD-0E15-3EED7832F2D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6951973" y="3943166"/>
              <a:ext cx="3286540" cy="2464905"/>
            </a:xfrm>
            <a:prstGeom prst="rect">
              <a:avLst/>
            </a:prstGeom>
          </p:spPr>
        </p:pic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C6DD50C9-1586-1552-AF90-1DC5DC0BC213}"/>
                </a:ext>
              </a:extLst>
            </p:cNvPr>
            <p:cNvSpPr/>
            <p:nvPr/>
          </p:nvSpPr>
          <p:spPr>
            <a:xfrm rot="18970210" flipV="1">
              <a:off x="2629776" y="2327786"/>
              <a:ext cx="416325" cy="60170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56B924C-5D86-F89E-8431-7D1EF0A1C2C0}"/>
                </a:ext>
              </a:extLst>
            </p:cNvPr>
            <p:cNvSpPr txBox="1"/>
            <p:nvPr/>
          </p:nvSpPr>
          <p:spPr>
            <a:xfrm>
              <a:off x="4779096" y="142458"/>
              <a:ext cx="1465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EVG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BD27835D-9D1F-E275-6358-C9245B966FFD}"/>
                </a:ext>
              </a:extLst>
            </p:cNvPr>
            <p:cNvSpPr txBox="1"/>
            <p:nvPr/>
          </p:nvSpPr>
          <p:spPr>
            <a:xfrm>
              <a:off x="7329773" y="142458"/>
              <a:ext cx="1465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MMP-12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0CC6E12B-8241-C6CC-DFCD-CCE4D6D64D67}"/>
                </a:ext>
              </a:extLst>
            </p:cNvPr>
            <p:cNvSpPr txBox="1"/>
            <p:nvPr/>
          </p:nvSpPr>
          <p:spPr>
            <a:xfrm>
              <a:off x="2180770" y="3059664"/>
              <a:ext cx="1465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EVG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C4CE1E3-F450-7838-B712-346807D5CDC0}"/>
                </a:ext>
              </a:extLst>
            </p:cNvPr>
            <p:cNvSpPr txBox="1"/>
            <p:nvPr/>
          </p:nvSpPr>
          <p:spPr>
            <a:xfrm>
              <a:off x="4829550" y="3481232"/>
              <a:ext cx="1465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E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64EDEE9-AFD1-5C3E-BFDB-8366B23F687C}"/>
                </a:ext>
              </a:extLst>
            </p:cNvPr>
            <p:cNvSpPr txBox="1"/>
            <p:nvPr/>
          </p:nvSpPr>
          <p:spPr>
            <a:xfrm>
              <a:off x="7362790" y="3481232"/>
              <a:ext cx="1465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MC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Text Box 5">
            <a:extLst>
              <a:ext uri="{FF2B5EF4-FFF2-40B4-BE49-F238E27FC236}">
                <a16:creationId xmlns:a16="http://schemas.microsoft.com/office/drawing/2014/main" id="{CCBEABBF-175F-71ED-6449-A310E0287A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121" y="3908988"/>
            <a:ext cx="4567722" cy="25853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800" b="1" dirty="0"/>
              <a:t>S-Fig.2 Demonstration of medial elastin destruction and co-localization with MMP-12 staining (arrows). </a:t>
            </a:r>
            <a:r>
              <a:rPr lang="en-US" altLang="ja-JP" sz="1800" dirty="0"/>
              <a:t>Serial sections of aorta of a transgenic rabbits was stained with EVG and HE stain or immunohistochemically stained with antibodies against MMP-12 and smooth muscle </a:t>
            </a:r>
            <a:r>
              <a:rPr lang="en-US" altLang="ja-JP" sz="1800" dirty="0">
                <a:latin typeface="Symbol" panose="05050102010706020507" pitchFamily="18" charset="2"/>
              </a:rPr>
              <a:t>a</a:t>
            </a:r>
            <a:r>
              <a:rPr lang="en-US" altLang="ja-JP" sz="1800" dirty="0"/>
              <a:t>-actin as described in the materials and methods.</a:t>
            </a:r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287BC1DE-5949-0B64-DFD1-7CD7C0EAAE4D}"/>
              </a:ext>
            </a:extLst>
          </p:cNvPr>
          <p:cNvGrpSpPr/>
          <p:nvPr/>
        </p:nvGrpSpPr>
        <p:grpSpPr>
          <a:xfrm>
            <a:off x="6494727" y="1649895"/>
            <a:ext cx="876795" cy="337931"/>
            <a:chOff x="6494727" y="1649895"/>
            <a:chExt cx="876795" cy="337931"/>
          </a:xfrm>
        </p:grpSpPr>
        <p:cxnSp>
          <p:nvCxnSpPr>
            <p:cNvPr id="24" name="直線矢印コネクタ 23">
              <a:extLst>
                <a:ext uri="{FF2B5EF4-FFF2-40B4-BE49-F238E27FC236}">
                  <a16:creationId xmlns:a16="http://schemas.microsoft.com/office/drawing/2014/main" id="{C25A6698-C62F-8EA9-740D-D1A7ED276809}"/>
                </a:ext>
              </a:extLst>
            </p:cNvPr>
            <p:cNvCxnSpPr>
              <a:cxnSpLocks/>
            </p:cNvCxnSpPr>
            <p:nvPr/>
          </p:nvCxnSpPr>
          <p:spPr>
            <a:xfrm>
              <a:off x="6977270" y="1649895"/>
              <a:ext cx="0" cy="337931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57C7D76B-E606-A9E9-09DF-2B853D926638}"/>
                </a:ext>
              </a:extLst>
            </p:cNvPr>
            <p:cNvCxnSpPr>
              <a:cxnSpLocks/>
            </p:cNvCxnSpPr>
            <p:nvPr/>
          </p:nvCxnSpPr>
          <p:spPr>
            <a:xfrm>
              <a:off x="6494727" y="1649895"/>
              <a:ext cx="0" cy="337931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id="{BA79AAEE-C6D7-E550-E351-A1240474E828}"/>
                </a:ext>
              </a:extLst>
            </p:cNvPr>
            <p:cNvCxnSpPr>
              <a:cxnSpLocks/>
            </p:cNvCxnSpPr>
            <p:nvPr/>
          </p:nvCxnSpPr>
          <p:spPr>
            <a:xfrm>
              <a:off x="7371522" y="1649895"/>
              <a:ext cx="0" cy="337931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8BC8B9AC-4681-718D-DC4E-17D6494ECDE1}"/>
              </a:ext>
            </a:extLst>
          </p:cNvPr>
          <p:cNvGrpSpPr/>
          <p:nvPr/>
        </p:nvGrpSpPr>
        <p:grpSpPr>
          <a:xfrm>
            <a:off x="8734338" y="1524003"/>
            <a:ext cx="876795" cy="337931"/>
            <a:chOff x="6494727" y="1649895"/>
            <a:chExt cx="876795" cy="337931"/>
          </a:xfrm>
        </p:grpSpPr>
        <p:cxnSp>
          <p:nvCxnSpPr>
            <p:cNvPr id="33" name="直線矢印コネクタ 32">
              <a:extLst>
                <a:ext uri="{FF2B5EF4-FFF2-40B4-BE49-F238E27FC236}">
                  <a16:creationId xmlns:a16="http://schemas.microsoft.com/office/drawing/2014/main" id="{A0280E4C-993C-1574-6F02-BA4F8CF1AD39}"/>
                </a:ext>
              </a:extLst>
            </p:cNvPr>
            <p:cNvCxnSpPr>
              <a:cxnSpLocks/>
            </p:cNvCxnSpPr>
            <p:nvPr/>
          </p:nvCxnSpPr>
          <p:spPr>
            <a:xfrm>
              <a:off x="6977270" y="1649895"/>
              <a:ext cx="0" cy="337931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4F6FB8D6-9395-C645-A90C-C3BBA9D355F1}"/>
                </a:ext>
              </a:extLst>
            </p:cNvPr>
            <p:cNvCxnSpPr>
              <a:cxnSpLocks/>
            </p:cNvCxnSpPr>
            <p:nvPr/>
          </p:nvCxnSpPr>
          <p:spPr>
            <a:xfrm>
              <a:off x="6494727" y="1649895"/>
              <a:ext cx="0" cy="337931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4FF95F51-6877-AF0E-0E08-55F0ECE5C5B7}"/>
                </a:ext>
              </a:extLst>
            </p:cNvPr>
            <p:cNvCxnSpPr>
              <a:cxnSpLocks/>
            </p:cNvCxnSpPr>
            <p:nvPr/>
          </p:nvCxnSpPr>
          <p:spPr>
            <a:xfrm>
              <a:off x="7371522" y="1649895"/>
              <a:ext cx="0" cy="337931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48026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55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ianglin</dc:creator>
  <cp:lastModifiedBy>jianglin</cp:lastModifiedBy>
  <cp:revision>1</cp:revision>
  <dcterms:created xsi:type="dcterms:W3CDTF">2022-12-17T06:31:57Z</dcterms:created>
  <dcterms:modified xsi:type="dcterms:W3CDTF">2022-12-17T07:31:57Z</dcterms:modified>
</cp:coreProperties>
</file>